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1BCD30-0AFD-4D98-BF15-86885452C7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66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27666-A98D-4933-91FF-BCB8581490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11BDD-BF2D-4983-A167-3E8072018F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560A9-49DD-41F2-86A7-FE722A3F66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F3F43-9B03-4776-9489-E780058C27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DEDF8-0603-4438-BF60-88A551CE54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4BF89-0EB6-4030-9A32-0B0A57C0B7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916B3-2A7B-4609-94FC-A380BA5266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14B70-23F4-48A5-A2BA-2C1FDCF419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9A16B-5CFA-4619-B4C7-3AB0AD4DE4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DD96F-DB6B-4C29-9FE7-2416958759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BFA133-97E8-4A4F-8CDB-E0C75A263A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788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788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788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E5FDEA-E880-4950-BFE2-DF5999C2505F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62120" y="8383680"/>
            <a:ext cx="556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. Distributions of grain width in the four NIL populations grown in Zhejiang and Hainan, respectively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533520" y="382680"/>
            <a:ext cx="5810040" cy="7924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02T02:57:20Z</dcterms:created>
  <dc:creator>Administrator</dc:creator>
  <dc:description/>
  <dc:language>en-US</dc:language>
  <cp:lastModifiedBy>Reviewer</cp:lastModifiedBy>
  <dcterms:modified xsi:type="dcterms:W3CDTF">2016-06-03T01:39:29Z</dcterms:modified>
  <cp:revision>1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